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248" autoAdjust="0"/>
  </p:normalViewPr>
  <p:slideViewPr>
    <p:cSldViewPr snapToGrid="0" showGuides="1">
      <p:cViewPr>
        <p:scale>
          <a:sx n="66" d="100"/>
          <a:sy n="66" d="100"/>
        </p:scale>
        <p:origin x="1224" y="23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3232D3-61E5-486E-A49E-F2E9E060B8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23B7C0-D605-4C80-841A-2C602A0C92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A9254-C390-4F43-AF86-254EEAB92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295EB-B000-4632-B77D-175FA6ECF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B406D-26AC-4EE0-A179-C0CBDE07F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41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D13551-2D4B-49A8-B63A-54816F128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4E0E5F-BEF6-471F-9A3A-BB99D82EC9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434FE-C648-4339-9FC1-E9CA57C78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F7B077-246F-4213-A9EE-39D3FEDAC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828C33-D1C8-463C-B3EA-D70766C20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607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73DA6E-0C33-441C-A7DF-7E92517C11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CA0E21-8CD5-4CC2-9E98-395C325C38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C6E9C-B3DB-46FD-A155-42050A981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57902C-C796-4FB0-A2D3-704F378F6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6B02C-3DD6-4D16-9179-C50C5DD3C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921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B51A1-F537-431E-85E9-6225DE852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D30AB3-F987-4F97-8F92-619EAFD894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2C4F9C-2C89-480C-82D0-FAE2A0DAD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7078C7-0556-4553-827D-D80CE051D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511CC-6947-4DF0-9E4F-98640CB9C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717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CA6526-847B-4BCD-A533-E603BEC45A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02C3FC-4FE2-4E43-8718-D6061F3775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7A189-CB13-4085-8D3E-CC6F53CF5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807426-32F9-4C1E-B735-5E0BAC743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CDAD62-03F4-4CAD-9AC2-9912F5279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147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5A24B-5B16-477E-89DD-F0F0377AEA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FB5BF4-7453-4653-87B5-B6A23F2929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AB3A2E-1B16-42E6-8FDB-B1B2614C65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E809B9-758D-4C81-93E9-50DCD2E3B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EC1260-1423-4FD8-B35B-FC6767757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3A3A47-804E-415A-95BE-1C3D884B1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89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94D7D7-3EA8-4A5E-82DB-00FC9F8A4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46F500-1C24-4AEC-8DFE-78AB81D8B1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147915-B1D5-4BAC-A15F-7A03FA388B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CE5891-5C76-4A4C-828D-FFA6DDC15C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B09D8F-5FB3-41C2-A2A8-21D8105455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386E79-C3CB-4DDF-B458-5379B8CDF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14FD45-AF72-4D50-A5BB-82AC7F9C8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7DB905-A03F-49E1-9B5A-B48049ECE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233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CD263-E15A-4937-81CF-5F5CB416F7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04D0E3-6DEE-493A-AD15-A172D1286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59DBFF-3275-4A21-A21B-C98C5921D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E938F9-9337-409A-945C-CA96CEE6D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0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94BB8B-E1A9-4A3E-B759-E3CEA9711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0B7E77-138D-4408-BE4D-355E67A49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CB5147-D84A-47AE-95AD-A40AB94CD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549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F32818-02B5-452C-A370-F3C4D3DC8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95075C-659D-4343-AAE9-55CECFCD45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838CF-AC8B-4485-A0DF-13189DF755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F59971-A250-480E-BF5D-9410C2ADA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97D1B-0F27-44F8-A53E-9CD836669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0714E-B3D4-47E9-83B6-B197E77CF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53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757E5-48EF-4B1F-A8D3-5C0F1B9F10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82D430-A695-4D84-B557-470F69F233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22EF48-3BE8-413F-8F73-492A987D8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5A7232-2EAA-403A-91B7-AE0FB8845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2416A8-F4E4-41A3-B8F4-4A9413925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CC17A5-6180-4E07-B681-E7131680F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42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FE2029-8F42-41CA-9DB9-2DC1314C1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77AF25-864B-45FC-85FD-82F8414E92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12A3D-1EB6-4C64-9D34-9ADDB0A312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29A29-C0C1-4970-8CFA-9102BDA0BFE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45E18-81AE-4F66-97A7-8AF72CF24E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6B6C0D-A539-4A76-A6D6-67024BA1D0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157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EBB1522-FBC4-47EA-B2E5-A32D1C1888E7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2DF4B23-46FD-4575-BB41-4F40033A3F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9780"/>
            <a:ext cx="12192000" cy="5515881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422184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ue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41927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2457A51-4922-4DCD-8B45-7F26CB54DF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99AB2F5-92D5-4E76-9EDF-4C9377F2BE2E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610377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own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6731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A95F186-AF3E-4B6D-B7CF-555FEB0690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EC1168B-B58F-4AA6-8E00-A3C7DAA04FE1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636025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ey60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6196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5FDEE79-1AF9-4489-847C-901DEFC90D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10072EC-3169-4D7C-B0B3-B78EF5F890D0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969450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ghtgreen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8947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AEE4876-7DD5-4FC9-AFCD-828B729176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9C385B8-7137-4B8F-9E1A-1E2356E293A6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2050561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ghtyellow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67223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CD48CF6-0B39-4406-8AC4-4AD2D7CBB8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7037DB7-3B9E-4AAB-A982-51598C032862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2294218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dnightblue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18338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8039125-CB1F-4CFE-A7DC-2A9A90BC81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8D886D7-F133-4C39-9036-6BB67B57D1F4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422184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ink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6156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E83E2F0-109A-402C-BC91-9B99541F54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057C2C7-7B24-4DDE-8892-575F1E72B9C4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627369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urple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14474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AE5C71B-9C54-4028-9FB5-8382B2F310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1AA995E-7A22-4910-AD2B-282079257162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nine candidate modules. Large circles and orange octagons represent hub-high traffic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30200" y="6178623"/>
            <a:ext cx="1905330" cy="3740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rquoise module</a:t>
            </a:r>
            <a:endParaRPr lang="en-US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1253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297</Words>
  <Application>Microsoft Office PowerPoint</Application>
  <PresentationFormat>Widescreen</PresentationFormat>
  <Paragraphs>1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akbar_H</dc:creator>
  <cp:lastModifiedBy>Aliakbar_H</cp:lastModifiedBy>
  <cp:revision>18</cp:revision>
  <dcterms:created xsi:type="dcterms:W3CDTF">2021-08-04T16:00:08Z</dcterms:created>
  <dcterms:modified xsi:type="dcterms:W3CDTF">2021-10-03T14:35:17Z</dcterms:modified>
</cp:coreProperties>
</file>